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48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zhang25\Desktop\Tri%20paper%20revise\07262018-RNA%20TR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zhang25\Desktop\Tri%20paper%20revise\07262018-RNA%20TR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 smtClean="0"/>
              <a:t>SU-DHL16</a:t>
            </a:r>
            <a:endParaRPr lang="en-US" sz="1800" b="1" dirty="0"/>
          </a:p>
        </c:rich>
      </c:tx>
      <c:layout>
        <c:manualLayout>
          <c:xMode val="edge"/>
          <c:yMode val="edge"/>
          <c:x val="0.40371745843226636"/>
          <c:y val="4.14301150005023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3286876640419949"/>
          <c:y val="0.17158155557643059"/>
          <c:w val="0.54272887139107606"/>
          <c:h val="0.62439575771482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 w="12700" cap="flat" cmpd="sng" algn="ctr">
              <a:solidFill>
                <a:schemeClr val="accent3">
                  <a:shade val="50000"/>
                </a:schemeClr>
              </a:solidFill>
              <a:prstDash val="solid"/>
              <a:miter lim="800000"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analysis!$S$14:$S$17</c:f>
                <c:numCache>
                  <c:formatCode>General</c:formatCode>
                  <c:ptCount val="4"/>
                  <c:pt idx="0">
                    <c:v>0.13540059942598037</c:v>
                  </c:pt>
                  <c:pt idx="1">
                    <c:v>7.4433108388308744E-2</c:v>
                  </c:pt>
                  <c:pt idx="2">
                    <c:v>8.6289963132641034E-2</c:v>
                  </c:pt>
                  <c:pt idx="3">
                    <c:v>8.5316562911272431E-2</c:v>
                  </c:pt>
                </c:numCache>
              </c:numRef>
            </c:plus>
            <c:minus>
              <c:numRef>
                <c:f>analysis!$U$14:$U$17</c:f>
                <c:numCache>
                  <c:formatCode>General</c:formatCode>
                  <c:ptCount val="4"/>
                  <c:pt idx="0">
                    <c:v>0.11925359163491223</c:v>
                  </c:pt>
                  <c:pt idx="1">
                    <c:v>6.9664106965714234E-2</c:v>
                  </c:pt>
                  <c:pt idx="2">
                    <c:v>8.1142359818255461E-2</c:v>
                  </c:pt>
                  <c:pt idx="3">
                    <c:v>8.07912309319740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nalysis!$I$14:$I$17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</c:numCache>
            </c:numRef>
          </c:cat>
          <c:val>
            <c:numRef>
              <c:f>analysis!$Q$14:$Q$17</c:f>
              <c:numCache>
                <c:formatCode>0.000</c:formatCode>
                <c:ptCount val="4"/>
                <c:pt idx="0">
                  <c:v>1</c:v>
                </c:pt>
                <c:pt idx="1">
                  <c:v>1.0872959693379756</c:v>
                </c:pt>
                <c:pt idx="2">
                  <c:v>1.360200234863739</c:v>
                </c:pt>
                <c:pt idx="3">
                  <c:v>1.52316563028279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CD-4BB4-B13D-2D1731087FAC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7208664"/>
        <c:axId val="407209056"/>
      </c:barChart>
      <c:catAx>
        <c:axId val="407208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HHT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7209056"/>
        <c:crosses val="autoZero"/>
        <c:auto val="1"/>
        <c:lblAlgn val="ctr"/>
        <c:lblOffset val="100"/>
        <c:noMultiLvlLbl val="0"/>
      </c:catAx>
      <c:valAx>
        <c:axId val="407209056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MCL-1 v.s.</a:t>
                </a:r>
                <a:b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600" b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8969028871391071E-2"/>
              <c:y val="0.248216493908683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720866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dirty="0" smtClean="0"/>
              <a:t>SU-DHL4 </a:t>
            </a:r>
            <a:endParaRPr lang="en-US" sz="1800" b="1" dirty="0"/>
          </a:p>
        </c:rich>
      </c:tx>
      <c:layout>
        <c:manualLayout>
          <c:xMode val="edge"/>
          <c:yMode val="edge"/>
          <c:x val="0.42858292762967187"/>
          <c:y val="5.010965609197853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3286876640419949"/>
          <c:y val="0.17158155557643059"/>
          <c:w val="0.54272887139107606"/>
          <c:h val="0.62439575771482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 w="12700" cap="flat" cmpd="sng" algn="ctr">
              <a:solidFill>
                <a:schemeClr val="accent3">
                  <a:shade val="50000"/>
                </a:schemeClr>
              </a:solidFill>
              <a:prstDash val="solid"/>
              <a:miter lim="800000"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analysis!$S$6:$S$9</c:f>
                <c:numCache>
                  <c:formatCode>General</c:formatCode>
                  <c:ptCount val="4"/>
                  <c:pt idx="0">
                    <c:v>0.22278635662586233</c:v>
                  </c:pt>
                  <c:pt idx="1">
                    <c:v>0.22918569634436237</c:v>
                  </c:pt>
                  <c:pt idx="2">
                    <c:v>8.093062991122002E-2</c:v>
                  </c:pt>
                  <c:pt idx="3">
                    <c:v>0.62881718831119349</c:v>
                  </c:pt>
                </c:numCache>
              </c:numRef>
            </c:plus>
            <c:minus>
              <c:numRef>
                <c:f>analysis!$U$6:$U$9</c:f>
                <c:numCache>
                  <c:formatCode>General</c:formatCode>
                  <c:ptCount val="4"/>
                  <c:pt idx="0">
                    <c:v>0.18219565128336523</c:v>
                  </c:pt>
                  <c:pt idx="1">
                    <c:v>0.19953606891163367</c:v>
                  </c:pt>
                  <c:pt idx="2">
                    <c:v>7.8113670416387393E-2</c:v>
                  </c:pt>
                  <c:pt idx="3">
                    <c:v>0.508092775763598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nalysis!$I$6:$I$9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</c:numCache>
            </c:numRef>
          </c:cat>
          <c:val>
            <c:numRef>
              <c:f>analysis!$Q$6:$Q$9</c:f>
              <c:numCache>
                <c:formatCode>0.0</c:formatCode>
                <c:ptCount val="4"/>
                <c:pt idx="0">
                  <c:v>1</c:v>
                </c:pt>
                <c:pt idx="1">
                  <c:v>1.5423739472978912</c:v>
                </c:pt>
                <c:pt idx="2">
                  <c:v>2.2441886591099016</c:v>
                </c:pt>
                <c:pt idx="3">
                  <c:v>2.6465025914367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3B-44AC-9D58-C410966652E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7209840"/>
        <c:axId val="407210232"/>
      </c:barChart>
      <c:catAx>
        <c:axId val="4072098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HHT (nM)</a:t>
                </a:r>
              </a:p>
            </c:rich>
          </c:tx>
          <c:layout>
            <c:manualLayout>
              <c:xMode val="edge"/>
              <c:yMode val="edge"/>
              <c:x val="0.44221670964339171"/>
              <c:y val="0.907128910321204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7210232"/>
        <c:crosses val="autoZero"/>
        <c:auto val="1"/>
        <c:lblAlgn val="ctr"/>
        <c:lblOffset val="100"/>
        <c:noMultiLvlLbl val="0"/>
      </c:catAx>
      <c:valAx>
        <c:axId val="407210232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MCL-1 v.s.</a:t>
                </a:r>
                <a:b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en-US" sz="16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600" b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8969028871391071E-2"/>
              <c:y val="0.248216493908683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72098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46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347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88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60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894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62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709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797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940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868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78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D2751-9093-443D-BAF5-70203CEC01B1}" type="datetimeFigureOut">
              <a:rPr lang="en-US" smtClean="0"/>
              <a:t>10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ACAF6-CE31-4AC8-8B3C-B060CBD84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13" Type="http://schemas.openxmlformats.org/officeDocument/2006/relationships/image" Target="../media/image8.jpeg"/><Relationship Id="rId3" Type="http://schemas.openxmlformats.org/officeDocument/2006/relationships/chart" Target="../charts/chart2.xml"/><Relationship Id="rId7" Type="http://schemas.microsoft.com/office/2007/relationships/hdphoto" Target="../media/hdphoto2.wdp"/><Relationship Id="rId12" Type="http://schemas.openxmlformats.org/officeDocument/2006/relationships/image" Target="../media/image7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1" Type="http://schemas.openxmlformats.org/officeDocument/2006/relationships/image" Target="../media/image6.jpeg"/><Relationship Id="rId5" Type="http://schemas.microsoft.com/office/2007/relationships/hdphoto" Target="../media/hdphoto1.wdp"/><Relationship Id="rId15" Type="http://schemas.openxmlformats.org/officeDocument/2006/relationships/image" Target="../media/image10.jpeg"/><Relationship Id="rId10" Type="http://schemas.openxmlformats.org/officeDocument/2006/relationships/image" Target="../media/image5.jpeg"/><Relationship Id="rId4" Type="http://schemas.openxmlformats.org/officeDocument/2006/relationships/image" Target="../media/image1.png"/><Relationship Id="rId9" Type="http://schemas.openxmlformats.org/officeDocument/2006/relationships/image" Target="../media/image4.jpeg"/><Relationship Id="rId1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 71"/>
          <p:cNvGrpSpPr/>
          <p:nvPr/>
        </p:nvGrpSpPr>
        <p:grpSpPr>
          <a:xfrm>
            <a:off x="4541502" y="775493"/>
            <a:ext cx="6939240" cy="3024132"/>
            <a:chOff x="41903" y="1319270"/>
            <a:chExt cx="6939240" cy="3024132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/>
            </p:nvPr>
          </p:nvGraphicFramePr>
          <p:xfrm>
            <a:off x="3830442" y="1416980"/>
            <a:ext cx="3150701" cy="29264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/>
            <p:cNvGraphicFramePr>
              <a:graphicFrameLocks/>
            </p:cNvGraphicFramePr>
            <p:nvPr>
              <p:extLst/>
            </p:nvPr>
          </p:nvGraphicFramePr>
          <p:xfrm>
            <a:off x="248771" y="1416980"/>
            <a:ext cx="3553086" cy="29264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41903" y="131927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63894" y="4826047"/>
            <a:ext cx="2833552" cy="1514794"/>
            <a:chOff x="2816042" y="969233"/>
            <a:chExt cx="2833552" cy="1514794"/>
          </a:xfrm>
        </p:grpSpPr>
        <p:sp>
          <p:nvSpPr>
            <p:cNvPr id="20" name="Rectangle 19"/>
            <p:cNvSpPr/>
            <p:nvPr/>
          </p:nvSpPr>
          <p:spPr>
            <a:xfrm>
              <a:off x="4420424" y="969233"/>
              <a:ext cx="51809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ct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096151" y="1394524"/>
              <a:ext cx="60465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HT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33490" y="1368923"/>
              <a:ext cx="191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    +    -     +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4426159" y="1368922"/>
              <a:ext cx="548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2816042" y="2145473"/>
              <a:ext cx="8528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β</a:t>
              </a: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actin</a:t>
              </a:r>
              <a:endParaRPr kumimoji="0" lang="en-US" sz="16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824964" y="1755158"/>
              <a:ext cx="843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CL-1</a:t>
              </a:r>
              <a:endParaRPr kumimoji="0" lang="en-US" sz="16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71" t="36556" r="63983" b="57432"/>
            <a:stretch/>
          </p:blipFill>
          <p:spPr>
            <a:xfrm>
              <a:off x="3707265" y="1733463"/>
              <a:ext cx="1280160" cy="3231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90" t="42907" r="58649" b="49888"/>
            <a:stretch/>
          </p:blipFill>
          <p:spPr>
            <a:xfrm>
              <a:off x="3707265" y="2144512"/>
              <a:ext cx="1280160" cy="3179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8" name="Group 27"/>
          <p:cNvGrpSpPr/>
          <p:nvPr/>
        </p:nvGrpSpPr>
        <p:grpSpPr>
          <a:xfrm>
            <a:off x="3041005" y="4788258"/>
            <a:ext cx="1632273" cy="1526999"/>
            <a:chOff x="8725782" y="990339"/>
            <a:chExt cx="1632273" cy="1526999"/>
          </a:xfrm>
        </p:grpSpPr>
        <p:sp>
          <p:nvSpPr>
            <p:cNvPr id="29" name="Rectangle 28"/>
            <p:cNvSpPr/>
            <p:nvPr/>
          </p:nvSpPr>
          <p:spPr>
            <a:xfrm>
              <a:off x="9468186" y="990339"/>
              <a:ext cx="51809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ct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725782" y="1380212"/>
              <a:ext cx="16322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     +    -    +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9455141" y="1368922"/>
              <a:ext cx="548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42" t="41828" r="63159" b="51080"/>
            <a:stretch/>
          </p:blipFill>
          <p:spPr>
            <a:xfrm>
              <a:off x="8725782" y="1742868"/>
              <a:ext cx="1280160" cy="3639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26" t="39422" r="57810" b="52082"/>
            <a:stretch/>
          </p:blipFill>
          <p:spPr>
            <a:xfrm>
              <a:off x="8725782" y="2186894"/>
              <a:ext cx="1280160" cy="3304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4" name="Rectangle 33"/>
          <p:cNvSpPr/>
          <p:nvPr/>
        </p:nvSpPr>
        <p:spPr>
          <a:xfrm>
            <a:off x="6887853" y="4758361"/>
            <a:ext cx="11336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hx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2h) 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5713589" y="5163526"/>
            <a:ext cx="60465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HT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478685" y="5151553"/>
            <a:ext cx="191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    +    -    +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7135164" y="5151552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391304" y="6031852"/>
            <a:ext cx="10225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actin</a:t>
            </a:r>
            <a:endParaRPr kumimoji="0" lang="en-US" sz="1600" b="0" i="0" u="none" strike="noStrike" kern="1200" cap="none" spc="0" normalizeH="0" baseline="-25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625880" y="5587817"/>
            <a:ext cx="843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CL-1</a:t>
            </a:r>
            <a:endParaRPr kumimoji="0" lang="en-US" sz="1600" b="0" i="0" u="none" strike="noStrike" kern="1200" cap="none" spc="0" normalizeH="0" baseline="-25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8069554" y="4773121"/>
            <a:ext cx="10695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hx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4h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7704078" y="5163526"/>
            <a:ext cx="191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    +    -    +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8304870" y="5151552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837" t="45527" r="18567" b="47835"/>
          <a:stretch/>
        </p:blipFill>
        <p:spPr>
          <a:xfrm>
            <a:off x="6413887" y="5541143"/>
            <a:ext cx="2560320" cy="3630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70" t="44110" r="17375" b="49934"/>
          <a:stretch/>
        </p:blipFill>
        <p:spPr>
          <a:xfrm>
            <a:off x="6413886" y="6032633"/>
            <a:ext cx="2560320" cy="3328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02" t="41201" r="21550" b="51541"/>
          <a:stretch/>
        </p:blipFill>
        <p:spPr>
          <a:xfrm>
            <a:off x="9414079" y="5552442"/>
            <a:ext cx="2560320" cy="335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29" t="39263" r="16028" b="52082"/>
          <a:stretch/>
        </p:blipFill>
        <p:spPr>
          <a:xfrm>
            <a:off x="9414079" y="5946956"/>
            <a:ext cx="2560320" cy="3628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Rectangle 50"/>
          <p:cNvSpPr/>
          <p:nvPr/>
        </p:nvSpPr>
        <p:spPr>
          <a:xfrm>
            <a:off x="9884941" y="4812998"/>
            <a:ext cx="10695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hx</a:t>
            </a: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2h)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9469841" y="5221654"/>
            <a:ext cx="191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    +    -    +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>
            <a:off x="10126320" y="5221653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11272782" y="4812998"/>
            <a:ext cx="5950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hx</a:t>
            </a:r>
            <a:endParaRPr kumimoji="0" lang="en-US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0733334" y="5195527"/>
            <a:ext cx="191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     +    -     +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11296026" y="5221653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Rectangle 57"/>
          <p:cNvSpPr/>
          <p:nvPr/>
        </p:nvSpPr>
        <p:spPr>
          <a:xfrm>
            <a:off x="1433793" y="4441208"/>
            <a:ext cx="105990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-DHL4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3041005" y="4791416"/>
            <a:ext cx="13287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>
            <a:off x="3136825" y="4441208"/>
            <a:ext cx="11737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-DHL16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7135164" y="4364352"/>
            <a:ext cx="105990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-DHL4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10073792" y="4326249"/>
            <a:ext cx="11737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-DHL16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63" name="Straight Connector 62"/>
          <p:cNvCxnSpPr/>
          <p:nvPr/>
        </p:nvCxnSpPr>
        <p:spPr>
          <a:xfrm>
            <a:off x="9358202" y="4714060"/>
            <a:ext cx="26049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6413886" y="4714060"/>
            <a:ext cx="2560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H="1">
            <a:off x="1223608" y="4791416"/>
            <a:ext cx="13847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1" name="Group 70"/>
          <p:cNvGrpSpPr/>
          <p:nvPr/>
        </p:nvGrpSpPr>
        <p:grpSpPr>
          <a:xfrm>
            <a:off x="382383" y="873203"/>
            <a:ext cx="3623026" cy="2715099"/>
            <a:chOff x="7662991" y="1194400"/>
            <a:chExt cx="3623026" cy="2715099"/>
          </a:xfrm>
        </p:grpSpPr>
        <p:sp>
          <p:nvSpPr>
            <p:cNvPr id="4" name="TextBox 3"/>
            <p:cNvSpPr txBox="1"/>
            <p:nvPr/>
          </p:nvSpPr>
          <p:spPr>
            <a:xfrm>
              <a:off x="8528195" y="2427357"/>
              <a:ext cx="14492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   20  40  80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5" name="Straight Connector 4"/>
            <p:cNvCxnSpPr/>
            <p:nvPr/>
          </p:nvCxnSpPr>
          <p:spPr>
            <a:xfrm>
              <a:off x="8720144" y="2358479"/>
              <a:ext cx="914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8566295" y="3561962"/>
              <a:ext cx="8333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8</a:t>
              </a: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662991" y="3244427"/>
              <a:ext cx="8528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β</a:t>
              </a: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actin</a:t>
              </a:r>
              <a:endParaRPr kumimoji="0" lang="en-US" sz="16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7885292" y="2434263"/>
              <a:ext cx="71635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HT  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697436" y="2823628"/>
              <a:ext cx="843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CL-1</a:t>
              </a:r>
              <a:endParaRPr kumimoji="0" lang="en-US" sz="16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8645701" y="2002637"/>
              <a:ext cx="105990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U-DHL4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10015544" y="2358479"/>
              <a:ext cx="914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9933174" y="2001562"/>
              <a:ext cx="11737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U-DHL16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93" t="44861" r="59531" b="46986"/>
            <a:stretch/>
          </p:blipFill>
          <p:spPr>
            <a:xfrm>
              <a:off x="8555612" y="2752927"/>
              <a:ext cx="1233407" cy="3924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14" t="45689" r="60342" b="47338"/>
            <a:stretch/>
          </p:blipFill>
          <p:spPr>
            <a:xfrm>
              <a:off x="8546691" y="3236369"/>
              <a:ext cx="1241316" cy="3255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06" t="44593" r="47138" b="46844"/>
            <a:stretch/>
          </p:blipFill>
          <p:spPr>
            <a:xfrm>
              <a:off x="9886956" y="2779722"/>
              <a:ext cx="1253393" cy="365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08" t="46672" r="39491" b="46530"/>
            <a:stretch/>
          </p:blipFill>
          <p:spPr>
            <a:xfrm>
              <a:off x="9896557" y="3236369"/>
              <a:ext cx="1243792" cy="3081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TextBox 16"/>
            <p:cNvSpPr txBox="1"/>
            <p:nvPr/>
          </p:nvSpPr>
          <p:spPr>
            <a:xfrm>
              <a:off x="9927109" y="3570945"/>
              <a:ext cx="8333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8</a:t>
              </a: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9841391" y="2424250"/>
              <a:ext cx="144462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0   5   </a:t>
              </a: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  </a:t>
              </a:r>
              <a:r>
                <a:rPr kumimoji="0" lang="en-US" sz="16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0 </a:t>
              </a:r>
              <a:endPara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704892" y="11944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67" name="TextBox 66"/>
          <p:cNvSpPr txBox="1"/>
          <p:nvPr/>
        </p:nvSpPr>
        <p:spPr>
          <a:xfrm>
            <a:off x="429093" y="40802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462213" y="42079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45106" y="111665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4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28240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  Nguyen</dc:creator>
  <cp:lastModifiedBy>Tri  Nguyen</cp:lastModifiedBy>
  <cp:revision>1</cp:revision>
  <dcterms:created xsi:type="dcterms:W3CDTF">2018-10-03T18:47:57Z</dcterms:created>
  <dcterms:modified xsi:type="dcterms:W3CDTF">2018-10-03T18:48:07Z</dcterms:modified>
</cp:coreProperties>
</file>